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014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612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4AC202-7814-EFF5-040C-54206509BC9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79D1CA-2774-45F9-E305-636C11FA0B9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MY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25104C-4BA5-9132-0A95-445C65C054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B105A-2242-4FA0-AB5A-52637E44F443}" type="datetimeFigureOut">
              <a:rPr lang="en-MY" smtClean="0"/>
              <a:t>8/8/2025</a:t>
            </a:fld>
            <a:endParaRPr lang="en-MY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E32989-04B7-E074-9545-90754D1B6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6D5AE7-E2C6-03A3-79A6-EBC8A20D99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3973A-1780-4011-9CF2-F5921E0E607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9489930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8652B1-F699-7939-317F-F89F5C397C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8F5C50-F897-294F-58DB-FEC584060E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22EECC-E5C2-E16D-45BA-405C9BC01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B105A-2242-4FA0-AB5A-52637E44F443}" type="datetimeFigureOut">
              <a:rPr lang="en-MY" smtClean="0"/>
              <a:t>8/8/2025</a:t>
            </a:fld>
            <a:endParaRPr lang="en-MY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5462F2-3DFF-EA09-402D-B60ED7BEC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7DEDD-19C4-77FD-E378-4BFBE8922D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3973A-1780-4011-9CF2-F5921E0E607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608868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B037E01-BE09-CD71-CE45-79519AD7929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BC8E9B-C075-77EC-1A2B-8324F4A864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0690DF-1677-7F17-314E-1DC41545C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B105A-2242-4FA0-AB5A-52637E44F443}" type="datetimeFigureOut">
              <a:rPr lang="en-MY" smtClean="0"/>
              <a:t>8/8/2025</a:t>
            </a:fld>
            <a:endParaRPr lang="en-MY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E805D5-2D1F-6997-1C99-251A419088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121AFC-E6B2-36B0-BE8C-930B485B6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3973A-1780-4011-9CF2-F5921E0E607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1613855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4A79D1-1A85-2E63-E297-078D28988B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BD61B5-F6C6-FC45-B68D-3EEBDA958C1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6EB1FB-AC3C-2472-5E81-756177AF6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B105A-2242-4FA0-AB5A-52637E44F443}" type="datetimeFigureOut">
              <a:rPr lang="en-MY" smtClean="0"/>
              <a:t>8/8/2025</a:t>
            </a:fld>
            <a:endParaRPr lang="en-MY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AB0BB7-A2B6-B2FF-6D04-98DB8EC260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A42F8F-1818-7C8C-5E1E-6DA498D4A8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3973A-1780-4011-9CF2-F5921E0E607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449200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3FC7BC-E11D-0DDE-D2FB-42820D0A88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ACBC3B9-6674-CC89-EA3F-40F5A2885E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29166B7-72E3-A178-0A20-90264AB3E5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B105A-2242-4FA0-AB5A-52637E44F443}" type="datetimeFigureOut">
              <a:rPr lang="en-MY" smtClean="0"/>
              <a:t>8/8/2025</a:t>
            </a:fld>
            <a:endParaRPr lang="en-MY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1A7471-6CBB-1946-0B0A-399AF5CFC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3829750-4B36-2CB9-3719-2BEF1158B0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3973A-1780-4011-9CF2-F5921E0E607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1167661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3F89BA-A73A-F3FA-1194-C0A64630E7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5202B5-613C-5FD3-B162-05956A9CC8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A14707-9D85-7993-8754-14A11DBB0B3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EF62A9-02CD-6781-5DD2-AB8DC7C0DD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B105A-2242-4FA0-AB5A-52637E44F443}" type="datetimeFigureOut">
              <a:rPr lang="en-MY" smtClean="0"/>
              <a:t>8/8/2025</a:t>
            </a:fld>
            <a:endParaRPr lang="en-MY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B1F53C-6C22-3FAC-50B0-18B933AC3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E9202C-F3AF-977A-5B9C-E02FE5705C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3973A-1780-4011-9CF2-F5921E0E607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425382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8176EA-4688-667A-6711-CDF7C18C12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17A9EF2-879D-CC07-41C5-502867F1A3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58DD5F-E289-A481-A75E-B77C4C6A4A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2A97034-302B-A92A-6748-C87A1D8624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FF1644F-3B23-384E-702F-F16594BEEB3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FA5D71-A7FC-2D4B-F906-5A7B4EFAC2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B105A-2242-4FA0-AB5A-52637E44F443}" type="datetimeFigureOut">
              <a:rPr lang="en-MY" smtClean="0"/>
              <a:t>8/8/2025</a:t>
            </a:fld>
            <a:endParaRPr lang="en-MY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61F0D97-38C4-AA9C-0D83-2810835226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B3CCD6-26E5-F64C-477E-97C42E744C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3973A-1780-4011-9CF2-F5921E0E607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9807276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4C5437-BC4B-870F-43DC-D6D3823EBF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5E27AE4-A819-C828-C204-119A7353E7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B105A-2242-4FA0-AB5A-52637E44F443}" type="datetimeFigureOut">
              <a:rPr lang="en-MY" smtClean="0"/>
              <a:t>8/8/2025</a:t>
            </a:fld>
            <a:endParaRPr lang="en-MY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891231E-187F-38FC-7E07-F66E86BF6C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E393DCF-0471-B38B-6FFD-DC49890C41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3973A-1780-4011-9CF2-F5921E0E607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856019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2DE3938-D652-C848-EFB6-028604F07A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B105A-2242-4FA0-AB5A-52637E44F443}" type="datetimeFigureOut">
              <a:rPr lang="en-MY" smtClean="0"/>
              <a:t>8/8/2025</a:t>
            </a:fld>
            <a:endParaRPr lang="en-MY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2947694-3DE6-8ECF-7371-95175C0532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25B7BA7-33F7-1D60-50D7-2E73EB6DEE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3973A-1780-4011-9CF2-F5921E0E607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1408483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EF0F3F-D339-A089-16EE-E44996159D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CA4CD2-FDCD-2BA3-7B95-8945D8EAB0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BB2105D-694C-CF0D-3FCD-05E84C789D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50C40A5-8FE3-18ED-07EF-58AE8D8BF0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B105A-2242-4FA0-AB5A-52637E44F443}" type="datetimeFigureOut">
              <a:rPr lang="en-MY" smtClean="0"/>
              <a:t>8/8/2025</a:t>
            </a:fld>
            <a:endParaRPr lang="en-MY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E9D216-311E-4DA4-AAAB-92DAE8FA1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E1FCA3F-FCA6-61A6-2CB8-6B460C3883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3973A-1780-4011-9CF2-F5921E0E607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41839068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F4E6E1-5CD0-1756-6F50-81F31B5B87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C53B8FD-B258-69A9-29C7-B62F1BF2AE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MY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6DC1653-AFC7-6CE5-5DB3-F5494434F8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245EC8-472E-07CA-26D5-DC5DD3202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EB105A-2242-4FA0-AB5A-52637E44F443}" type="datetimeFigureOut">
              <a:rPr lang="en-MY" smtClean="0"/>
              <a:t>8/8/2025</a:t>
            </a:fld>
            <a:endParaRPr lang="en-MY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99B9BF-0FDA-5E9A-6D17-C3AEA5A35F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MY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C226B1-B2F9-46DF-8BE6-BE19FCF82B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6F3973A-1780-4011-9CF2-F5921E0E607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878361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F9386C-5108-E901-52D9-E841039D6A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MY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66F3274-1A1D-50DE-3891-CD7BC4813F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DB071D-D1B5-3154-F5DC-1A43AA1314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EB105A-2242-4FA0-AB5A-52637E44F443}" type="datetimeFigureOut">
              <a:rPr lang="en-MY" smtClean="0"/>
              <a:t>8/8/2025</a:t>
            </a:fld>
            <a:endParaRPr lang="en-MY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6FCB84-1AC2-6692-801B-5CFCC103E6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MY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592DDC-82FC-AA56-9E5A-AA395C27103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F3973A-1780-4011-9CF2-F5921E0E607A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2653818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29A9E58-A85A-7CDB-F777-399D509B064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2661" b="6446"/>
          <a:stretch/>
        </p:blipFill>
        <p:spPr>
          <a:xfrm>
            <a:off x="1298605" y="166914"/>
            <a:ext cx="9754445" cy="570206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FC3732A-BB87-9530-D6E9-369236BA98CC}"/>
              </a:ext>
            </a:extLst>
          </p:cNvPr>
          <p:cNvSpPr txBox="1"/>
          <p:nvPr/>
        </p:nvSpPr>
        <p:spPr>
          <a:xfrm>
            <a:off x="1132115" y="5965372"/>
            <a:ext cx="105673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Material </a:t>
            </a: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ninsular Malaysia map with a focus on Kelantan, displaying district boundaries and labels for spatial reference.</a:t>
            </a:r>
            <a:endParaRPr lang="en-MY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215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DB70B0DE03C3042A6D0E80739F87E81" ma:contentTypeVersion="13" ma:contentTypeDescription="Create a new document." ma:contentTypeScope="" ma:versionID="26268c07bb18a13e08643b597f0a52f4">
  <xsd:schema xmlns:xsd="http://www.w3.org/2001/XMLSchema" xmlns:xs="http://www.w3.org/2001/XMLSchema" xmlns:p="http://schemas.microsoft.com/office/2006/metadata/properties" xmlns:ns3="1435f0ce-29ed-49eb-8012-082fed7482e1" targetNamespace="http://schemas.microsoft.com/office/2006/metadata/properties" ma:root="true" ma:fieldsID="a25104349b62a012552ed455136d8682" ns3:_="">
    <xsd:import namespace="1435f0ce-29ed-49eb-8012-082fed7482e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  <xsd:element ref="ns3:MediaServiceDateTaken" minOccurs="0"/>
                <xsd:element ref="ns3:MediaLengthInSeconds" minOccurs="0"/>
                <xsd:element ref="ns3:_activity" minOccurs="0"/>
                <xsd:element ref="ns3:MediaServiceObjectDetectorVersions" minOccurs="0"/>
                <xsd:element ref="ns3:MediaServiceLocation" minOccurs="0"/>
                <xsd:element ref="ns3:MediaServiceSystemTag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435f0ce-29ed-49eb-8012-082fed7482e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2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4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LengthInSeconds" ma:index="15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16" nillable="true" ma:displayName="_activity" ma:hidden="true" ma:internalName="_activity">
      <xsd:simpleType>
        <xsd:restriction base="dms:Note"/>
      </xsd:simpleType>
    </xsd:element>
    <xsd:element name="MediaServiceObjectDetectorVersions" ma:index="17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Location" ma:index="18" nillable="true" ma:displayName="Location" ma:indexed="true" ma:internalName="MediaServiceLocation" ma:readOnly="true">
      <xsd:simpleType>
        <xsd:restriction base="dms:Text"/>
      </xsd:simpleType>
    </xsd:element>
    <xsd:element name="MediaServiceSystemTags" ma:index="19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1435f0ce-29ed-49eb-8012-082fed7482e1" xsi:nil="true"/>
  </documentManagement>
</p:properties>
</file>

<file path=customXml/itemProps1.xml><?xml version="1.0" encoding="utf-8"?>
<ds:datastoreItem xmlns:ds="http://schemas.openxmlformats.org/officeDocument/2006/customXml" ds:itemID="{D1605ABD-D870-4DBC-87C6-D913D7958DBE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8670F1B0-95E8-4454-9851-824D78A65D5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1435f0ce-29ed-49eb-8012-082fed7482e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58303C81-B201-4836-A593-5FDE546332DA}">
  <ds:schemaRefs>
    <ds:schemaRef ds:uri="http://schemas.microsoft.com/office/infopath/2007/PartnerControls"/>
    <ds:schemaRef ds:uri="http://purl.org/dc/terms/"/>
    <ds:schemaRef ds:uri="1435f0ce-29ed-49eb-8012-082fed7482e1"/>
    <ds:schemaRef ds:uri="http://purl.org/dc/dcmitype/"/>
    <ds:schemaRef ds:uri="http://schemas.microsoft.com/office/2006/documentManagement/types"/>
    <ds:schemaRef ds:uri="http://purl.org/dc/elements/1.1/"/>
    <ds:schemaRef ds:uri="http://schemas.microsoft.com/office/2006/metadata/properties"/>
    <ds:schemaRef ds:uri="http://schemas.openxmlformats.org/package/2006/metadata/core-propertie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22</Words>
  <Application>Microsoft Office PowerPoint</Application>
  <PresentationFormat>와이드스크린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Hazlienor Mohd Hatta</dc:creator>
  <cp:lastModifiedBy>User</cp:lastModifiedBy>
  <cp:revision>3</cp:revision>
  <dcterms:created xsi:type="dcterms:W3CDTF">2025-02-27T12:00:21Z</dcterms:created>
  <dcterms:modified xsi:type="dcterms:W3CDTF">2025-08-08T07:46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DB70B0DE03C3042A6D0E80739F87E81</vt:lpwstr>
  </property>
</Properties>
</file>